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nrique María Mateu de Antonio" userId="678ddb83-0020-4a06-85d2-928a222534ef" providerId="ADAL" clId="{998B7C74-D490-4CDA-84AB-70B8D9935A13}"/>
    <pc:docChg chg="modSld">
      <pc:chgData name="Enrique María Mateu de Antonio" userId="678ddb83-0020-4a06-85d2-928a222534ef" providerId="ADAL" clId="{998B7C74-D490-4CDA-84AB-70B8D9935A13}" dt="2025-04-22T12:48:01.174" v="1" actId="2711"/>
      <pc:docMkLst>
        <pc:docMk/>
      </pc:docMkLst>
      <pc:sldChg chg="modSp mod">
        <pc:chgData name="Enrique María Mateu de Antonio" userId="678ddb83-0020-4a06-85d2-928a222534ef" providerId="ADAL" clId="{998B7C74-D490-4CDA-84AB-70B8D9935A13}" dt="2025-04-22T12:48:01.174" v="1" actId="2711"/>
        <pc:sldMkLst>
          <pc:docMk/>
          <pc:sldMk cId="702709687" sldId="257"/>
        </pc:sldMkLst>
        <pc:spChg chg="mod">
          <ac:chgData name="Enrique María Mateu de Antonio" userId="678ddb83-0020-4a06-85d2-928a222534ef" providerId="ADAL" clId="{998B7C74-D490-4CDA-84AB-70B8D9935A13}" dt="2025-04-22T12:48:01.174" v="1" actId="2711"/>
          <ac:spMkLst>
            <pc:docMk/>
            <pc:sldMk cId="702709687" sldId="257"/>
            <ac:spMk id="12" creationId="{D1491EBB-993F-E0AF-3A54-D00CBA5A9B2C}"/>
          </ac:spMkLst>
        </pc:spChg>
      </pc:sldChg>
    </pc:docChg>
  </pc:docChgLst>
  <pc:docChgLst>
    <pc:chgData name="Enrique María Mateu de Antonio" userId="678ddb83-0020-4a06-85d2-928a222534ef" providerId="ADAL" clId="{EF7438AE-40F1-4644-850F-8DFC026B988F}"/>
    <pc:docChg chg="undo custSel modSld">
      <pc:chgData name="Enrique María Mateu de Antonio" userId="678ddb83-0020-4a06-85d2-928a222534ef" providerId="ADAL" clId="{EF7438AE-40F1-4644-850F-8DFC026B988F}" dt="2025-04-07T13:47:07.140" v="11" actId="113"/>
      <pc:docMkLst>
        <pc:docMk/>
      </pc:docMkLst>
      <pc:sldChg chg="addSp modSp mod">
        <pc:chgData name="Enrique María Mateu de Antonio" userId="678ddb83-0020-4a06-85d2-928a222534ef" providerId="ADAL" clId="{EF7438AE-40F1-4644-850F-8DFC026B988F}" dt="2025-04-07T13:47:07.140" v="11" actId="113"/>
        <pc:sldMkLst>
          <pc:docMk/>
          <pc:sldMk cId="702709687" sldId="257"/>
        </pc:sldMkLst>
        <pc:spChg chg="add mod">
          <ac:chgData name="Enrique María Mateu de Antonio" userId="678ddb83-0020-4a06-85d2-928a222534ef" providerId="ADAL" clId="{EF7438AE-40F1-4644-850F-8DFC026B988F}" dt="2025-04-07T13:47:07.140" v="11" actId="113"/>
          <ac:spMkLst>
            <pc:docMk/>
            <pc:sldMk cId="702709687" sldId="257"/>
            <ac:spMk id="12" creationId="{D1491EBB-993F-E0AF-3A54-D00CBA5A9B2C}"/>
          </ac:spMkLst>
        </pc:spChg>
        <pc:grpChg chg="mod">
          <ac:chgData name="Enrique María Mateu de Antonio" userId="678ddb83-0020-4a06-85d2-928a222534ef" providerId="ADAL" clId="{EF7438AE-40F1-4644-850F-8DFC026B988F}" dt="2025-04-07T13:46:53.399" v="3" actId="1076"/>
          <ac:grpSpMkLst>
            <pc:docMk/>
            <pc:sldMk cId="702709687" sldId="257"/>
            <ac:grpSpMk id="11" creationId="{DF4DCBEC-F6D4-8FA6-C1DB-3D083572CBB0}"/>
          </ac:grpSpMkLst>
        </pc:grpChg>
        <pc:graphicFrameChg chg="mod">
          <ac:chgData name="Enrique María Mateu de Antonio" userId="678ddb83-0020-4a06-85d2-928a222534ef" providerId="ADAL" clId="{EF7438AE-40F1-4644-850F-8DFC026B988F}" dt="2025-04-07T13:46:35.333" v="1" actId="1076"/>
          <ac:graphicFrameMkLst>
            <pc:docMk/>
            <pc:sldMk cId="702709687" sldId="257"/>
            <ac:graphicFrameMk id="3" creationId="{65E800B3-83E9-5A04-A410-4EC499FA2F2E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92C10C0-2339-B699-EFC0-D193499F77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6060D02F-63C0-4EA0-D446-072C53DF4C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6EF3C06B-FE61-FE23-77FD-59FB94FB8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E992E911-45F7-B816-7E14-579688036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80B6AAC7-03C2-0476-1CB5-303151208B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9090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5B10A0D3-14CB-5439-93DC-466E0C19EB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3586FD08-6ACF-C5CE-DD6C-BC81A195A9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72F8FABE-2DE4-9955-7118-4DCAB78D6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9C009A36-150E-7116-2DFC-106980ED7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F6457FD0-21DD-3A63-6BAF-4669CB805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5742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2250B93D-F49B-77A1-5654-A434557BF2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D76C3252-8252-F361-20C5-625F1D8D2D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6FA555E4-B6F8-674F-311B-5BBA221ECA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C93175C8-3D2A-011C-1982-9EC908EBB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3721FCFB-EEA1-AEDD-C054-74E811770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252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AD9D737-7B10-2896-21D6-448B6ACC1D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C8312C39-C3DA-A92C-57B4-5C99667BAF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CC66A582-6ACB-D11C-B59F-6C6B9877D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8C6EFD94-8A4F-F428-6ECC-515401CBB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5C4E9E25-10EF-D934-FEB6-940AB20A0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2881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5B3D5A2F-1A3C-5847-7FA9-37C51AA75C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190ECC62-0019-B75F-B447-02D75D69AA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36AAA858-3EBD-ACCB-1FFD-FEBA4C67A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CEEDEBDB-6D42-009D-218A-7D6B2C526B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D9B9E051-FD83-0490-6CCB-71BC0B06E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3844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72D94588-015F-2A24-2161-B248AC3A0B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174FC884-70CA-328D-4047-218B0F994F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8686540D-77E3-0115-5C30-33A0EFC637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FD4B069B-0EA9-40C7-98CD-90FB576DC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5F5FA3D5-5277-9902-EC42-8750AB2B4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8EC0A978-EA1F-66F2-023B-9310D62FC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5336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1E350736-FF77-6836-F7E6-6568A2EFB2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A695F5DC-FB2A-B974-7E64-80D9DE79CC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E213A0F3-C208-7F36-D311-4364A313EE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D83F589F-0367-9C7A-9A5D-4D2B03FDAC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D6934FA4-7E40-7363-531C-8D7C5021E9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0C15B3F7-217B-303E-7C18-531248F78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4368A142-4205-FC8D-E3E2-867DE1B70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33F6F1D8-4566-06D0-B8BE-C8852A3EC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5495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65068A07-B09A-5E81-6D7D-5C16667B59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83E1C11E-518A-2537-F80D-AC38211B3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AAB6A39E-5FAB-0A09-2701-91A1DEAC4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C54FE12B-C5ED-4359-3504-ECD9CDDE8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1133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567FB918-7552-359A-98A4-63CF91CF9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8DC628E0-991F-2DD8-CDC3-1F579C69A9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3CB245C8-F4B1-ADE9-7138-9478F5217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45423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0D5D3A77-26E3-2D93-95B2-6FB1B7E24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D68C7B4B-D054-A6DA-7E7A-EBCE67B577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B8F77697-8759-FAF5-7040-A23994107C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CB64E886-6F1B-7C6F-7607-EA48E4AC9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152B715D-9260-C5CD-5F52-7625821BE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05CED36F-07BA-E6B5-B05C-20E2ED4DF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8699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9E45F49F-BCD9-C5E7-7655-C2EC826CB2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EB7F90C4-5180-B49A-CABD-5A22F340D8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6A8B45D8-245D-5260-2801-7DD1DCF4D6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DF787E06-9D20-C529-B34C-5E5D97ADF4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E128B6EF-C867-A650-3AF4-43CD1C11CD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439BB70F-AE88-CF8B-64AF-269228A38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6827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C7CD299B-91CA-376D-008F-E48D58FD8E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22D4FB0F-014F-EA00-2249-631C5AEBA6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C5A9688-4B9E-B63B-8116-4CE67C28C5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17FD69-08CA-4485-9F9B-708A299D9266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A276A245-C150-3D4D-CBA1-6DB553317D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D27E58B9-356D-D667-E663-3EB5FFD2E6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0FA98F-BE8D-4543-AD59-F25C4E44026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8106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Agrupa 10">
            <a:extLst>
              <a:ext uri="{FF2B5EF4-FFF2-40B4-BE49-F238E27FC236}">
                <a16:creationId xmlns:a16="http://schemas.microsoft.com/office/drawing/2014/main" id="{DF4DCBEC-F6D4-8FA6-C1DB-3D083572CBB0}"/>
              </a:ext>
            </a:extLst>
          </p:cNvPr>
          <p:cNvGrpSpPr/>
          <p:nvPr/>
        </p:nvGrpSpPr>
        <p:grpSpPr>
          <a:xfrm>
            <a:off x="1801415" y="1146274"/>
            <a:ext cx="8589169" cy="5486301"/>
            <a:chOff x="956469" y="650974"/>
            <a:chExt cx="8589169" cy="5486301"/>
          </a:xfrm>
        </p:grpSpPr>
        <p:grpSp>
          <p:nvGrpSpPr>
            <p:cNvPr id="6" name="Agrupa 5">
              <a:extLst>
                <a:ext uri="{FF2B5EF4-FFF2-40B4-BE49-F238E27FC236}">
                  <a16:creationId xmlns:a16="http://schemas.microsoft.com/office/drawing/2014/main" id="{5B150662-0D9B-FFBE-E558-80D9544B8DE9}"/>
                </a:ext>
              </a:extLst>
            </p:cNvPr>
            <p:cNvGrpSpPr/>
            <p:nvPr/>
          </p:nvGrpSpPr>
          <p:grpSpPr>
            <a:xfrm>
              <a:off x="956469" y="650974"/>
              <a:ext cx="8589169" cy="5486301"/>
              <a:chOff x="956469" y="650974"/>
              <a:chExt cx="8589169" cy="5486301"/>
            </a:xfrm>
          </p:grpSpPr>
          <p:graphicFrame>
            <p:nvGraphicFramePr>
              <p:cNvPr id="3" name="Objecte 2">
                <a:extLst>
                  <a:ext uri="{FF2B5EF4-FFF2-40B4-BE49-F238E27FC236}">
                    <a16:creationId xmlns:a16="http://schemas.microsoft.com/office/drawing/2014/main" id="{65E800B3-83E9-5A04-A410-4EC499FA2F2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56535886"/>
                  </p:ext>
                </p:extLst>
              </p:nvPr>
            </p:nvGraphicFramePr>
            <p:xfrm>
              <a:off x="2646363" y="719138"/>
              <a:ext cx="6899275" cy="54181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2" imgW="8958376" imgH="7036329" progId="Prism10.Document">
                      <p:embed/>
                    </p:oleObj>
                  </mc:Choice>
                  <mc:Fallback>
                    <p:oleObj name="Prism 10" r:id="rId2" imgW="8958376" imgH="7036329" progId="Prism10.Document">
                      <p:embed/>
                      <p:pic>
                        <p:nvPicPr>
                          <p:cNvPr id="3" name="Objecte 2">
                            <a:extLst>
                              <a:ext uri="{FF2B5EF4-FFF2-40B4-BE49-F238E27FC236}">
                                <a16:creationId xmlns:a16="http://schemas.microsoft.com/office/drawing/2014/main" id="{65E800B3-83E9-5A04-A410-4EC499FA2F2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2646363" y="719138"/>
                            <a:ext cx="6899275" cy="54181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" name="QuadreDeText 3">
                <a:extLst>
                  <a:ext uri="{FF2B5EF4-FFF2-40B4-BE49-F238E27FC236}">
                    <a16:creationId xmlns:a16="http://schemas.microsoft.com/office/drawing/2014/main" id="{AA021920-13D4-060E-1A8C-667BA1FA1474}"/>
                  </a:ext>
                </a:extLst>
              </p:cNvPr>
              <p:cNvSpPr txBox="1"/>
              <p:nvPr/>
            </p:nvSpPr>
            <p:spPr>
              <a:xfrm>
                <a:off x="956469" y="650974"/>
                <a:ext cx="212407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)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ung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viral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oad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ca-ES" sz="1400" b="1" i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vs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.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icroscopic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esion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core</a:t>
                </a:r>
                <a:endParaRPr lang="es-ES" sz="14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" name="QuadreDeText 4">
                <a:extLst>
                  <a:ext uri="{FF2B5EF4-FFF2-40B4-BE49-F238E27FC236}">
                    <a16:creationId xmlns:a16="http://schemas.microsoft.com/office/drawing/2014/main" id="{40A79940-4504-34AC-E15D-340EAE08B250}"/>
                  </a:ext>
                </a:extLst>
              </p:cNvPr>
              <p:cNvSpPr txBox="1"/>
              <p:nvPr/>
            </p:nvSpPr>
            <p:spPr>
              <a:xfrm>
                <a:off x="956469" y="3132514"/>
                <a:ext cx="229552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)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Blood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viral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oad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ca-ES" sz="1400" b="1" i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vs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.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icroscopic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esion</a:t>
                </a:r>
                <a:r>
                  <a:rPr lang="ca-ES" sz="14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ca-ES" sz="1400" b="1" dirty="0" err="1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core</a:t>
                </a:r>
                <a:endParaRPr lang="es-ES" sz="14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7" name="QuadreDeText 6">
              <a:extLst>
                <a:ext uri="{FF2B5EF4-FFF2-40B4-BE49-F238E27FC236}">
                  <a16:creationId xmlns:a16="http://schemas.microsoft.com/office/drawing/2014/main" id="{A1E7BE62-8CB1-FE03-BAF7-31CF0A35FA10}"/>
                </a:ext>
              </a:extLst>
            </p:cNvPr>
            <p:cNvSpPr txBox="1"/>
            <p:nvPr/>
          </p:nvSpPr>
          <p:spPr>
            <a:xfrm>
              <a:off x="7868426" y="1272659"/>
              <a:ext cx="1677211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Y = </a:t>
              </a:r>
              <a:r>
                <a:rPr lang="es-ES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0.4010*X + 0.8077</a:t>
              </a:r>
            </a:p>
            <a:p>
              <a:r>
                <a:rPr lang="es-E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R</a:t>
              </a:r>
              <a:r>
                <a:rPr lang="es-ES" sz="1200" b="1" baseline="300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2</a:t>
              </a:r>
              <a:r>
                <a:rPr lang="es-ES" sz="12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 = </a:t>
              </a:r>
              <a:r>
                <a:rPr lang="es-ES" sz="12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0.5442; p&lt;0.001</a:t>
              </a:r>
            </a:p>
          </p:txBody>
        </p:sp>
        <p:sp>
          <p:nvSpPr>
            <p:cNvPr id="8" name="QuadreDeText 7">
              <a:extLst>
                <a:ext uri="{FF2B5EF4-FFF2-40B4-BE49-F238E27FC236}">
                  <a16:creationId xmlns:a16="http://schemas.microsoft.com/office/drawing/2014/main" id="{439F1262-AEC6-82BC-8F6A-4178BBD26CCF}"/>
                </a:ext>
              </a:extLst>
            </p:cNvPr>
            <p:cNvSpPr txBox="1"/>
            <p:nvPr/>
          </p:nvSpPr>
          <p:spPr>
            <a:xfrm>
              <a:off x="4306077" y="2415659"/>
              <a:ext cx="129462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ca-ES" sz="1200" b="1" dirty="0"/>
                <a:t>n</a:t>
              </a:r>
              <a:r>
                <a:rPr lang="es-ES" sz="1200" b="1" dirty="0" err="1"/>
                <a:t>on-significant</a:t>
              </a:r>
              <a:endParaRPr lang="es-ES" sz="1200" dirty="0"/>
            </a:p>
          </p:txBody>
        </p:sp>
        <p:sp>
          <p:nvSpPr>
            <p:cNvPr id="9" name="QuadreDeText 8">
              <a:extLst>
                <a:ext uri="{FF2B5EF4-FFF2-40B4-BE49-F238E27FC236}">
                  <a16:creationId xmlns:a16="http://schemas.microsoft.com/office/drawing/2014/main" id="{D3274104-ADEE-8D2D-9199-B97B7073AE97}"/>
                </a:ext>
              </a:extLst>
            </p:cNvPr>
            <p:cNvSpPr txBox="1"/>
            <p:nvPr/>
          </p:nvSpPr>
          <p:spPr>
            <a:xfrm>
              <a:off x="4306077" y="5120759"/>
              <a:ext cx="129462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ca-ES" sz="1200" b="1" dirty="0"/>
                <a:t>n</a:t>
              </a:r>
              <a:r>
                <a:rPr lang="es-ES" sz="1200" b="1" dirty="0" err="1"/>
                <a:t>on-significant</a:t>
              </a:r>
              <a:endParaRPr lang="es-ES" sz="1200" dirty="0"/>
            </a:p>
          </p:txBody>
        </p:sp>
        <p:sp>
          <p:nvSpPr>
            <p:cNvPr id="10" name="QuadreDeText 9">
              <a:extLst>
                <a:ext uri="{FF2B5EF4-FFF2-40B4-BE49-F238E27FC236}">
                  <a16:creationId xmlns:a16="http://schemas.microsoft.com/office/drawing/2014/main" id="{8C9C116A-977C-A71C-43E8-9C2843257D2F}"/>
                </a:ext>
              </a:extLst>
            </p:cNvPr>
            <p:cNvSpPr txBox="1"/>
            <p:nvPr/>
          </p:nvSpPr>
          <p:spPr>
            <a:xfrm>
              <a:off x="7868426" y="5120759"/>
              <a:ext cx="129462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ca-ES" sz="1200" b="1" dirty="0"/>
                <a:t>n</a:t>
              </a:r>
              <a:r>
                <a:rPr lang="es-ES" sz="1200" b="1" dirty="0" err="1"/>
                <a:t>on-significant</a:t>
              </a:r>
              <a:endParaRPr lang="es-ES" sz="1200" dirty="0"/>
            </a:p>
          </p:txBody>
        </p:sp>
      </p:grpSp>
      <p:sp>
        <p:nvSpPr>
          <p:cNvPr id="12" name="QuadreDeText 11">
            <a:extLst>
              <a:ext uri="{FF2B5EF4-FFF2-40B4-BE49-F238E27FC236}">
                <a16:creationId xmlns:a16="http://schemas.microsoft.com/office/drawing/2014/main" id="{D1491EBB-993F-E0AF-3A54-D00CBA5A9B2C}"/>
              </a:ext>
            </a:extLst>
          </p:cNvPr>
          <p:cNvSpPr txBox="1"/>
          <p:nvPr/>
        </p:nvSpPr>
        <p:spPr>
          <a:xfrm>
            <a:off x="733425" y="225425"/>
            <a:ext cx="111252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terial 7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l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ra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ad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scopic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u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s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ores at 10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28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t-challeng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PC). NV/Ch = non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d), Por =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rcil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RS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ang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IL = Innovac L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ccinat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lleng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lue). </a:t>
            </a:r>
          </a:p>
        </p:txBody>
      </p:sp>
    </p:spTree>
    <p:extLst>
      <p:ext uri="{BB962C8B-B14F-4D97-AF65-F5344CB8AC3E}">
        <p14:creationId xmlns:p14="http://schemas.microsoft.com/office/powerpoint/2010/main" val="7027096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icin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4</TotalTime>
  <Words>110</Words>
  <Application>Microsoft Office PowerPoint</Application>
  <PresentationFormat>Pantalla panoràmica</PresentationFormat>
  <Paragraphs>8</Paragraphs>
  <Slides>1</Slides>
  <Notes>0</Notes>
  <HiddenSlides>0</HiddenSlides>
  <MMClips>0</MMClips>
  <ScaleCrop>false</ScaleCrop>
  <HeadingPairs>
    <vt:vector size="8" baseType="variant">
      <vt:variant>
        <vt:lpstr>Tipus de lletra utilitzats</vt:lpstr>
      </vt:variant>
      <vt:variant>
        <vt:i4>5</vt:i4>
      </vt:variant>
      <vt:variant>
        <vt:lpstr>Tema</vt:lpstr>
      </vt:variant>
      <vt:variant>
        <vt:i4>1</vt:i4>
      </vt:variant>
      <vt:variant>
        <vt:lpstr>Servidors OLE incrustats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imes New Roman</vt:lpstr>
      <vt:lpstr>Tema de l'Office</vt:lpstr>
      <vt:lpstr>Prism 10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nrique María Mateu de Antonio</dc:creator>
  <cp:lastModifiedBy>Enrique María Mateu de Antonio</cp:lastModifiedBy>
  <cp:revision>2</cp:revision>
  <dcterms:created xsi:type="dcterms:W3CDTF">2025-02-18T13:34:31Z</dcterms:created>
  <dcterms:modified xsi:type="dcterms:W3CDTF">2025-04-22T12:48:04Z</dcterms:modified>
</cp:coreProperties>
</file>